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539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1290" y="72"/>
      </p:cViewPr>
      <p:guideLst>
        <p:guide orient="horz" pos="2160"/>
        <p:guide pos="53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87096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23253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93888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02887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56184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59207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59822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70461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02575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14911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43791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704BD-162F-49F5-849F-89A7F74CE840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F456B-A954-4DB3-9CFB-7A11118B988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78766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42663" y="1389873"/>
            <a:ext cx="6458674" cy="4078253"/>
            <a:chOff x="2407534" y="922010"/>
            <a:chExt cx="6458674" cy="4078253"/>
          </a:xfrm>
        </p:grpSpPr>
        <p:sp>
          <p:nvSpPr>
            <p:cNvPr id="5" name="Rectangle 4"/>
            <p:cNvSpPr/>
            <p:nvPr/>
          </p:nvSpPr>
          <p:spPr>
            <a:xfrm>
              <a:off x="2407534" y="922010"/>
              <a:ext cx="6458674" cy="407825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2641361" y="1097730"/>
              <a:ext cx="6107831" cy="3498625"/>
              <a:chOff x="761761" y="498290"/>
              <a:chExt cx="6107831" cy="3498625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761761" y="498290"/>
                <a:ext cx="6107831" cy="3498625"/>
                <a:chOff x="761761" y="498290"/>
                <a:chExt cx="6107831" cy="3498625"/>
              </a:xfrm>
            </p:grpSpPr>
            <p:grpSp>
              <p:nvGrpSpPr>
                <p:cNvPr id="9" name="Group 8"/>
                <p:cNvGrpSpPr/>
                <p:nvPr/>
              </p:nvGrpSpPr>
              <p:grpSpPr>
                <a:xfrm>
                  <a:off x="1041743" y="498290"/>
                  <a:ext cx="5827849" cy="3498625"/>
                  <a:chOff x="1041743" y="498290"/>
                  <a:chExt cx="5827849" cy="3498625"/>
                </a:xfrm>
              </p:grpSpPr>
              <p:grpSp>
                <p:nvGrpSpPr>
                  <p:cNvPr id="13" name="Group 12"/>
                  <p:cNvGrpSpPr/>
                  <p:nvPr/>
                </p:nvGrpSpPr>
                <p:grpSpPr>
                  <a:xfrm>
                    <a:off x="1071046" y="498290"/>
                    <a:ext cx="5798546" cy="941247"/>
                    <a:chOff x="1071046" y="498290"/>
                    <a:chExt cx="5798546" cy="941247"/>
                  </a:xfrm>
                </p:grpSpPr>
                <p:grpSp>
                  <p:nvGrpSpPr>
                    <p:cNvPr id="77" name="Group 76"/>
                    <p:cNvGrpSpPr/>
                    <p:nvPr/>
                  </p:nvGrpSpPr>
                  <p:grpSpPr>
                    <a:xfrm>
                      <a:off x="1071046" y="498290"/>
                      <a:ext cx="5798546" cy="941247"/>
                      <a:chOff x="1072521" y="470858"/>
                      <a:chExt cx="5798546" cy="941247"/>
                    </a:xfrm>
                  </p:grpSpPr>
                  <p:grpSp>
                    <p:nvGrpSpPr>
                      <p:cNvPr id="79" name="Group 78"/>
                      <p:cNvGrpSpPr/>
                      <p:nvPr/>
                    </p:nvGrpSpPr>
                    <p:grpSpPr>
                      <a:xfrm>
                        <a:off x="1072521" y="757121"/>
                        <a:ext cx="5798546" cy="654984"/>
                        <a:chOff x="2434977" y="4176977"/>
                        <a:chExt cx="5798546" cy="654984"/>
                      </a:xfrm>
                    </p:grpSpPr>
                    <p:grpSp>
                      <p:nvGrpSpPr>
                        <p:cNvPr id="81" name="Group 80"/>
                        <p:cNvGrpSpPr/>
                        <p:nvPr/>
                      </p:nvGrpSpPr>
                      <p:grpSpPr>
                        <a:xfrm>
                          <a:off x="2434977" y="4176977"/>
                          <a:ext cx="5798546" cy="654984"/>
                          <a:chOff x="2434977" y="4176977"/>
                          <a:chExt cx="5798546" cy="654984"/>
                        </a:xfrm>
                      </p:grpSpPr>
                      <p:cxnSp>
                        <p:nvCxnSpPr>
                          <p:cNvPr id="84" name="Straight Connector 83"/>
                          <p:cNvCxnSpPr>
                            <a:endCxn id="86" idx="3"/>
                          </p:cNvCxnSpPr>
                          <p:nvPr/>
                        </p:nvCxnSpPr>
                        <p:spPr>
                          <a:xfrm>
                            <a:off x="2670048" y="4535424"/>
                            <a:ext cx="5358383" cy="4572"/>
                          </a:xfrm>
                          <a:prstGeom prst="line">
                            <a:avLst/>
                          </a:prstGeom>
                          <a:ln w="254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85" name="Rectangle 84"/>
                          <p:cNvSpPr/>
                          <p:nvPr/>
                        </p:nvSpPr>
                        <p:spPr>
                          <a:xfrm>
                            <a:off x="2651760" y="4462272"/>
                            <a:ext cx="45719" cy="155448"/>
                          </a:xfrm>
                          <a:prstGeom prst="rect">
                            <a:avLst/>
                          </a:prstGeom>
                          <a:solidFill>
                            <a:schemeClr val="tx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86" name="Rectangle 85"/>
                          <p:cNvSpPr/>
                          <p:nvPr/>
                        </p:nvSpPr>
                        <p:spPr>
                          <a:xfrm>
                            <a:off x="7982712" y="4462272"/>
                            <a:ext cx="45719" cy="155448"/>
                          </a:xfrm>
                          <a:prstGeom prst="rect">
                            <a:avLst/>
                          </a:prstGeom>
                          <a:solidFill>
                            <a:schemeClr val="tx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87" name="Right Arrow 86"/>
                          <p:cNvSpPr/>
                          <p:nvPr/>
                        </p:nvSpPr>
                        <p:spPr>
                          <a:xfrm>
                            <a:off x="2909170" y="4427702"/>
                            <a:ext cx="350520" cy="227397"/>
                          </a:xfrm>
                          <a:prstGeom prst="rightArrow">
                            <a:avLst/>
                          </a:prstGeom>
                          <a:solidFill>
                            <a:srgbClr val="00B0F0"/>
                          </a:solidFill>
                          <a:ln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88" name="Right Arrow 87"/>
                          <p:cNvSpPr/>
                          <p:nvPr/>
                        </p:nvSpPr>
                        <p:spPr>
                          <a:xfrm>
                            <a:off x="5466442" y="4427702"/>
                            <a:ext cx="350520" cy="227397"/>
                          </a:xfrm>
                          <a:prstGeom prst="rightArrow">
                            <a:avLst/>
                          </a:prstGeom>
                          <a:solidFill>
                            <a:srgbClr val="00B0F0"/>
                          </a:solidFill>
                          <a:ln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89" name="Right Arrow 88"/>
                          <p:cNvSpPr/>
                          <p:nvPr/>
                        </p:nvSpPr>
                        <p:spPr>
                          <a:xfrm>
                            <a:off x="5195170" y="4427702"/>
                            <a:ext cx="222504" cy="227397"/>
                          </a:xfrm>
                          <a:prstGeom prst="rightArrow">
                            <a:avLst/>
                          </a:prstGeom>
                          <a:solidFill>
                            <a:srgbClr val="FF0000"/>
                          </a:solidFill>
                          <a:ln>
                            <a:solidFill>
                              <a:srgbClr val="FF000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0" name="Right Arrow 89"/>
                          <p:cNvSpPr/>
                          <p:nvPr/>
                        </p:nvSpPr>
                        <p:spPr>
                          <a:xfrm>
                            <a:off x="5893162" y="4427702"/>
                            <a:ext cx="390144" cy="227397"/>
                          </a:xfrm>
                          <a:prstGeom prst="rightArrow">
                            <a:avLst/>
                          </a:prstGeom>
                          <a:solidFill>
                            <a:srgbClr val="CC00CC"/>
                          </a:solidFill>
                          <a:ln>
                            <a:solidFill>
                              <a:srgbClr val="CC00CC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1" name="Right Arrow 90"/>
                          <p:cNvSpPr/>
                          <p:nvPr/>
                        </p:nvSpPr>
                        <p:spPr>
                          <a:xfrm>
                            <a:off x="6332074" y="4427702"/>
                            <a:ext cx="541020" cy="227397"/>
                          </a:xfrm>
                          <a:prstGeom prst="rightArrow">
                            <a:avLst/>
                          </a:prstGeom>
                          <a:solidFill>
                            <a:srgbClr val="FF0000"/>
                          </a:solidFill>
                          <a:ln>
                            <a:solidFill>
                              <a:srgbClr val="FF000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2" name="Right Arrow 91"/>
                          <p:cNvSpPr/>
                          <p:nvPr/>
                        </p:nvSpPr>
                        <p:spPr>
                          <a:xfrm>
                            <a:off x="7146652" y="4427702"/>
                            <a:ext cx="563118" cy="227397"/>
                          </a:xfrm>
                          <a:prstGeom prst="rightArrow">
                            <a:avLst/>
                          </a:prstGeom>
                          <a:solidFill>
                            <a:srgbClr val="0070C0"/>
                          </a:solidFill>
                          <a:ln>
                            <a:solidFill>
                              <a:srgbClr val="0070C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3" name="Rounded Rectangle 92"/>
                          <p:cNvSpPr/>
                          <p:nvPr/>
                        </p:nvSpPr>
                        <p:spPr>
                          <a:xfrm>
                            <a:off x="4518646" y="4467627"/>
                            <a:ext cx="160408" cy="148890"/>
                          </a:xfrm>
                          <a:prstGeom prst="roundRect">
                            <a:avLst/>
                          </a:prstGeom>
                          <a:solidFill>
                            <a:srgbClr val="92D050"/>
                          </a:solidFill>
                          <a:ln>
                            <a:solidFill>
                              <a:srgbClr val="92D05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4" name="TextBox 93"/>
                          <p:cNvSpPr txBox="1"/>
                          <p:nvPr/>
                        </p:nvSpPr>
                        <p:spPr>
                          <a:xfrm>
                            <a:off x="4249221" y="4176977"/>
                            <a:ext cx="455905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800" i="1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Mlu</a:t>
                            </a:r>
                            <a:r>
                              <a:rPr lang="en-GB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5" name="TextBox 94"/>
                          <p:cNvSpPr txBox="1"/>
                          <p:nvPr/>
                        </p:nvSpPr>
                        <p:spPr>
                          <a:xfrm>
                            <a:off x="4490031" y="4176977"/>
                            <a:ext cx="502593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800" i="1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Xma</a:t>
                            </a:r>
                            <a:r>
                              <a:rPr lang="en-GB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6" name="Rounded Rectangle 95"/>
                          <p:cNvSpPr/>
                          <p:nvPr/>
                        </p:nvSpPr>
                        <p:spPr>
                          <a:xfrm>
                            <a:off x="4440637" y="4467627"/>
                            <a:ext cx="78376" cy="148890"/>
                          </a:xfrm>
                          <a:prstGeom prst="roundRect">
                            <a:avLst/>
                          </a:prstGeom>
                          <a:solidFill>
                            <a:srgbClr val="00B0F0"/>
                          </a:solidFill>
                          <a:ln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7" name="Rounded Rectangle 96"/>
                          <p:cNvSpPr/>
                          <p:nvPr/>
                        </p:nvSpPr>
                        <p:spPr>
                          <a:xfrm>
                            <a:off x="3955929" y="4467627"/>
                            <a:ext cx="486988" cy="148890"/>
                          </a:xfrm>
                          <a:prstGeom prst="roundRect">
                            <a:avLst/>
                          </a:prstGeom>
                          <a:solidFill>
                            <a:srgbClr val="FF99FF"/>
                          </a:solidFill>
                          <a:ln>
                            <a:solidFill>
                              <a:srgbClr val="FF99FF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8" name="TextBox 97"/>
                          <p:cNvSpPr txBox="1"/>
                          <p:nvPr/>
                        </p:nvSpPr>
                        <p:spPr>
                          <a:xfrm>
                            <a:off x="3905180" y="4427702"/>
                            <a:ext cx="797997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Zera</a:t>
                            </a:r>
                            <a:r>
                              <a:rPr lang="en-GB" sz="800" baseline="300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®</a:t>
                            </a:r>
                            <a:r>
                              <a:rPr lang="en-US" sz="8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-VP2ep</a:t>
                            </a:r>
                          </a:p>
                        </p:txBody>
                      </p:sp>
                      <p:cxnSp>
                        <p:nvCxnSpPr>
                          <p:cNvPr id="99" name="Straight Connector 98"/>
                          <p:cNvCxnSpPr/>
                          <p:nvPr/>
                        </p:nvCxnSpPr>
                        <p:spPr>
                          <a:xfrm flipV="1">
                            <a:off x="4517604" y="4340437"/>
                            <a:ext cx="0" cy="124424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00" name="TextBox 99"/>
                          <p:cNvSpPr txBox="1"/>
                          <p:nvPr/>
                        </p:nvSpPr>
                        <p:spPr>
                          <a:xfrm>
                            <a:off x="3727976" y="4176977"/>
                            <a:ext cx="455905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800" i="1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Age</a:t>
                            </a:r>
                            <a:r>
                              <a:rPr lang="en-GB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101" name="Straight Connector 100"/>
                          <p:cNvCxnSpPr/>
                          <p:nvPr/>
                        </p:nvCxnSpPr>
                        <p:spPr>
                          <a:xfrm flipV="1">
                            <a:off x="3956772" y="4340437"/>
                            <a:ext cx="0" cy="124424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02" name="Straight Connector 101"/>
                          <p:cNvCxnSpPr/>
                          <p:nvPr/>
                        </p:nvCxnSpPr>
                        <p:spPr>
                          <a:xfrm flipV="1">
                            <a:off x="4670004" y="4340437"/>
                            <a:ext cx="0" cy="124424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03" name="TextBox 102"/>
                          <p:cNvSpPr txBox="1"/>
                          <p:nvPr/>
                        </p:nvSpPr>
                        <p:spPr>
                          <a:xfrm>
                            <a:off x="2434977" y="4268126"/>
                            <a:ext cx="455905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10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RB</a:t>
                            </a:r>
                            <a:endPara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04" name="TextBox 103"/>
                          <p:cNvSpPr txBox="1"/>
                          <p:nvPr/>
                        </p:nvSpPr>
                        <p:spPr>
                          <a:xfrm>
                            <a:off x="7777618" y="4268126"/>
                            <a:ext cx="455905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10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LB</a:t>
                            </a:r>
                            <a:endPara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05" name="TextBox 104"/>
                          <p:cNvSpPr txBox="1"/>
                          <p:nvPr/>
                        </p:nvSpPr>
                        <p:spPr>
                          <a:xfrm>
                            <a:off x="7055212" y="4427702"/>
                            <a:ext cx="563118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nptI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06" name="TextBox 105"/>
                          <p:cNvSpPr txBox="1"/>
                          <p:nvPr/>
                        </p:nvSpPr>
                        <p:spPr>
                          <a:xfrm>
                            <a:off x="5855676" y="4427702"/>
                            <a:ext cx="403129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8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p19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107" name="Straight Connector 106"/>
                          <p:cNvCxnSpPr/>
                          <p:nvPr/>
                        </p:nvCxnSpPr>
                        <p:spPr>
                          <a:xfrm flipV="1">
                            <a:off x="4724981" y="4535424"/>
                            <a:ext cx="0" cy="124424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08" name="TextBox 107"/>
                          <p:cNvSpPr txBox="1"/>
                          <p:nvPr/>
                        </p:nvSpPr>
                        <p:spPr>
                          <a:xfrm>
                            <a:off x="4494372" y="4616517"/>
                            <a:ext cx="502593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800" i="1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Xho</a:t>
                            </a:r>
                            <a:r>
                              <a:rPr lang="en-GB" sz="8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109" name="Straight Connector 108"/>
                          <p:cNvCxnSpPr/>
                          <p:nvPr/>
                        </p:nvCxnSpPr>
                        <p:spPr>
                          <a:xfrm>
                            <a:off x="3364992" y="4438962"/>
                            <a:ext cx="590936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rgbClr val="FFFF00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10" name="Straight Connector 109"/>
                          <p:cNvCxnSpPr/>
                          <p:nvPr/>
                        </p:nvCxnSpPr>
                        <p:spPr>
                          <a:xfrm>
                            <a:off x="4741327" y="4438962"/>
                            <a:ext cx="372184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rgbClr val="FFFF00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82" name="TextBox 81"/>
                        <p:cNvSpPr txBox="1"/>
                        <p:nvPr/>
                      </p:nvSpPr>
                      <p:spPr>
                        <a:xfrm>
                          <a:off x="3361374" y="4293436"/>
                          <a:ext cx="58080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6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PMV 5’UTR</a:t>
                          </a:r>
                          <a:endParaRPr lang="en-US" sz="6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83" name="TextBox 82"/>
                        <p:cNvSpPr txBox="1"/>
                        <p:nvPr/>
                      </p:nvSpPr>
                      <p:spPr>
                        <a:xfrm>
                          <a:off x="4630297" y="4293436"/>
                          <a:ext cx="58080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6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PMV 3’UTR</a:t>
                          </a:r>
                          <a:endParaRPr lang="en-US" sz="6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80" name="TextBox 79"/>
                      <p:cNvSpPr txBox="1"/>
                      <p:nvPr/>
                    </p:nvSpPr>
                    <p:spPr>
                      <a:xfrm>
                        <a:off x="3169412" y="470858"/>
                        <a:ext cx="1707458" cy="41549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100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EAQ-</a:t>
                        </a:r>
                        <a:r>
                          <a:rPr lang="en-GB" sz="1100" i="1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T</a:t>
                        </a:r>
                        <a:r>
                          <a:rPr lang="en-GB" sz="1100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Zera</a:t>
                        </a:r>
                        <a:r>
                          <a:rPr lang="en-GB" sz="1100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® </a:t>
                        </a:r>
                        <a:r>
                          <a:rPr lang="en-GB" sz="11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VP2ep</a:t>
                        </a:r>
                      </a:p>
                      <a:p>
                        <a:pPr algn="ctr"/>
                        <a:r>
                          <a:rPr lang="en-GB" sz="10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</a:t>
                        </a:r>
                        <a:endPara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78" name="Rounded Rectangle 77"/>
                    <p:cNvSpPr/>
                    <p:nvPr/>
                  </p:nvSpPr>
                  <p:spPr>
                    <a:xfrm>
                      <a:off x="2593472" y="1070010"/>
                      <a:ext cx="728864" cy="152885"/>
                    </a:xfrm>
                    <a:prstGeom prst="round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4" name="Group 13"/>
                  <p:cNvGrpSpPr/>
                  <p:nvPr/>
                </p:nvGrpSpPr>
                <p:grpSpPr>
                  <a:xfrm>
                    <a:off x="1056732" y="3285386"/>
                    <a:ext cx="5798546" cy="711529"/>
                    <a:chOff x="1072521" y="3602194"/>
                    <a:chExt cx="5798546" cy="711529"/>
                  </a:xfrm>
                </p:grpSpPr>
                <p:grpSp>
                  <p:nvGrpSpPr>
                    <p:cNvPr id="45" name="Group 44"/>
                    <p:cNvGrpSpPr/>
                    <p:nvPr/>
                  </p:nvGrpSpPr>
                  <p:grpSpPr>
                    <a:xfrm>
                      <a:off x="1072521" y="3602194"/>
                      <a:ext cx="5798546" cy="711529"/>
                      <a:chOff x="1072521" y="3602194"/>
                      <a:chExt cx="5798546" cy="711529"/>
                    </a:xfrm>
                  </p:grpSpPr>
                  <p:grpSp>
                    <p:nvGrpSpPr>
                      <p:cNvPr id="47" name="Group 46"/>
                      <p:cNvGrpSpPr/>
                      <p:nvPr/>
                    </p:nvGrpSpPr>
                    <p:grpSpPr>
                      <a:xfrm>
                        <a:off x="1072521" y="3835601"/>
                        <a:ext cx="5798546" cy="478122"/>
                        <a:chOff x="2434977" y="4176977"/>
                        <a:chExt cx="5798546" cy="478122"/>
                      </a:xfrm>
                    </p:grpSpPr>
                    <p:grpSp>
                      <p:nvGrpSpPr>
                        <p:cNvPr id="49" name="Group 48"/>
                        <p:cNvGrpSpPr/>
                        <p:nvPr/>
                      </p:nvGrpSpPr>
                      <p:grpSpPr>
                        <a:xfrm>
                          <a:off x="2434977" y="4176977"/>
                          <a:ext cx="5798546" cy="478122"/>
                          <a:chOff x="2434977" y="4176977"/>
                          <a:chExt cx="5798546" cy="478122"/>
                        </a:xfrm>
                      </p:grpSpPr>
                      <p:cxnSp>
                        <p:nvCxnSpPr>
                          <p:cNvPr id="52" name="Straight Connector 51"/>
                          <p:cNvCxnSpPr>
                            <a:endCxn id="54" idx="3"/>
                          </p:cNvCxnSpPr>
                          <p:nvPr/>
                        </p:nvCxnSpPr>
                        <p:spPr>
                          <a:xfrm>
                            <a:off x="2670048" y="4535424"/>
                            <a:ext cx="5358383" cy="4572"/>
                          </a:xfrm>
                          <a:prstGeom prst="line">
                            <a:avLst/>
                          </a:prstGeom>
                          <a:ln w="254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53" name="Rectangle 52"/>
                          <p:cNvSpPr/>
                          <p:nvPr/>
                        </p:nvSpPr>
                        <p:spPr>
                          <a:xfrm>
                            <a:off x="2651760" y="4462272"/>
                            <a:ext cx="45719" cy="155448"/>
                          </a:xfrm>
                          <a:prstGeom prst="rect">
                            <a:avLst/>
                          </a:prstGeom>
                          <a:solidFill>
                            <a:schemeClr val="tx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4" name="Rectangle 53"/>
                          <p:cNvSpPr/>
                          <p:nvPr/>
                        </p:nvSpPr>
                        <p:spPr>
                          <a:xfrm>
                            <a:off x="7982712" y="4462272"/>
                            <a:ext cx="45719" cy="155448"/>
                          </a:xfrm>
                          <a:prstGeom prst="rect">
                            <a:avLst/>
                          </a:prstGeom>
                          <a:solidFill>
                            <a:schemeClr val="tx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5" name="Right Arrow 54"/>
                          <p:cNvSpPr/>
                          <p:nvPr/>
                        </p:nvSpPr>
                        <p:spPr>
                          <a:xfrm>
                            <a:off x="2900026" y="4427702"/>
                            <a:ext cx="257617" cy="227397"/>
                          </a:xfrm>
                          <a:prstGeom prst="rightArrow">
                            <a:avLst/>
                          </a:prstGeom>
                          <a:solidFill>
                            <a:srgbClr val="00B0F0"/>
                          </a:solidFill>
                          <a:ln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6" name="Right Arrow 55"/>
                          <p:cNvSpPr/>
                          <p:nvPr/>
                        </p:nvSpPr>
                        <p:spPr>
                          <a:xfrm>
                            <a:off x="5777338" y="4427702"/>
                            <a:ext cx="297794" cy="227397"/>
                          </a:xfrm>
                          <a:prstGeom prst="rightArrow">
                            <a:avLst/>
                          </a:prstGeom>
                          <a:solidFill>
                            <a:srgbClr val="00B0F0"/>
                          </a:solidFill>
                          <a:ln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7" name="Right Arrow 56"/>
                          <p:cNvSpPr/>
                          <p:nvPr/>
                        </p:nvSpPr>
                        <p:spPr>
                          <a:xfrm>
                            <a:off x="5533498" y="4427702"/>
                            <a:ext cx="176292" cy="227397"/>
                          </a:xfrm>
                          <a:prstGeom prst="rightArrow">
                            <a:avLst/>
                          </a:prstGeom>
                          <a:solidFill>
                            <a:srgbClr val="FF0000"/>
                          </a:solidFill>
                          <a:ln>
                            <a:solidFill>
                              <a:srgbClr val="FF000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8" name="Right Arrow 57"/>
                          <p:cNvSpPr/>
                          <p:nvPr/>
                        </p:nvSpPr>
                        <p:spPr>
                          <a:xfrm>
                            <a:off x="6158338" y="4427702"/>
                            <a:ext cx="390144" cy="227397"/>
                          </a:xfrm>
                          <a:prstGeom prst="rightArrow">
                            <a:avLst/>
                          </a:prstGeom>
                          <a:solidFill>
                            <a:srgbClr val="CC00CC"/>
                          </a:solidFill>
                          <a:ln>
                            <a:solidFill>
                              <a:srgbClr val="CC00CC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9" name="Right Arrow 58"/>
                          <p:cNvSpPr/>
                          <p:nvPr/>
                        </p:nvSpPr>
                        <p:spPr>
                          <a:xfrm>
                            <a:off x="6578962" y="4427702"/>
                            <a:ext cx="426564" cy="227397"/>
                          </a:xfrm>
                          <a:prstGeom prst="rightArrow">
                            <a:avLst/>
                          </a:prstGeom>
                          <a:solidFill>
                            <a:srgbClr val="FF0000"/>
                          </a:solidFill>
                          <a:ln>
                            <a:solidFill>
                              <a:srgbClr val="FF000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60" name="Right Arrow 59"/>
                          <p:cNvSpPr/>
                          <p:nvPr/>
                        </p:nvSpPr>
                        <p:spPr>
                          <a:xfrm>
                            <a:off x="7146652" y="4427702"/>
                            <a:ext cx="435709" cy="227397"/>
                          </a:xfrm>
                          <a:prstGeom prst="rightArrow">
                            <a:avLst/>
                          </a:prstGeom>
                          <a:solidFill>
                            <a:srgbClr val="0070C0"/>
                          </a:solidFill>
                          <a:ln>
                            <a:solidFill>
                              <a:srgbClr val="0070C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61" name="Rounded Rectangle 60"/>
                          <p:cNvSpPr/>
                          <p:nvPr/>
                        </p:nvSpPr>
                        <p:spPr>
                          <a:xfrm>
                            <a:off x="4110918" y="4467627"/>
                            <a:ext cx="997307" cy="148890"/>
                          </a:xfrm>
                          <a:prstGeom prst="roundRect">
                            <a:avLst/>
                          </a:prstGeom>
                          <a:solidFill>
                            <a:srgbClr val="FF9933"/>
                          </a:solidFill>
                          <a:ln>
                            <a:solidFill>
                              <a:srgbClr val="FFC00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62" name="TextBox 61"/>
                          <p:cNvSpPr txBox="1"/>
                          <p:nvPr/>
                        </p:nvSpPr>
                        <p:spPr>
                          <a:xfrm>
                            <a:off x="3846885" y="4176977"/>
                            <a:ext cx="455905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800" i="1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Mlu</a:t>
                            </a:r>
                            <a:r>
                              <a:rPr lang="en-GB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63" name="Rounded Rectangle 62"/>
                          <p:cNvSpPr/>
                          <p:nvPr/>
                        </p:nvSpPr>
                        <p:spPr>
                          <a:xfrm>
                            <a:off x="4061399" y="4467627"/>
                            <a:ext cx="46134" cy="148890"/>
                          </a:xfrm>
                          <a:prstGeom prst="roundRect">
                            <a:avLst/>
                          </a:prstGeom>
                          <a:solidFill>
                            <a:srgbClr val="00B0F0"/>
                          </a:solidFill>
                          <a:ln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64" name="Rounded Rectangle 63"/>
                          <p:cNvSpPr/>
                          <p:nvPr/>
                        </p:nvSpPr>
                        <p:spPr>
                          <a:xfrm>
                            <a:off x="3790579" y="4467627"/>
                            <a:ext cx="256331" cy="148890"/>
                          </a:xfrm>
                          <a:prstGeom prst="roundRect">
                            <a:avLst/>
                          </a:prstGeom>
                          <a:solidFill>
                            <a:srgbClr val="FF99FF"/>
                          </a:solidFill>
                          <a:ln>
                            <a:solidFill>
                              <a:srgbClr val="FF99FF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65" name="TextBox 64"/>
                          <p:cNvSpPr txBox="1"/>
                          <p:nvPr/>
                        </p:nvSpPr>
                        <p:spPr>
                          <a:xfrm>
                            <a:off x="3818975" y="4435271"/>
                            <a:ext cx="1261819" cy="21982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Zera</a:t>
                            </a:r>
                            <a:r>
                              <a:rPr lang="en-GB" sz="800" baseline="300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®</a:t>
                            </a:r>
                            <a:r>
                              <a:rPr lang="en-US" sz="8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-</a:t>
                            </a:r>
                            <a:r>
                              <a:rPr lang="en-US" sz="8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VP2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66" name="Straight Connector 65"/>
                          <p:cNvCxnSpPr/>
                          <p:nvPr/>
                        </p:nvCxnSpPr>
                        <p:spPr>
                          <a:xfrm flipV="1">
                            <a:off x="4096980" y="4337848"/>
                            <a:ext cx="0" cy="124424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67" name="TextBox 66"/>
                          <p:cNvSpPr txBox="1"/>
                          <p:nvPr/>
                        </p:nvSpPr>
                        <p:spPr>
                          <a:xfrm>
                            <a:off x="3545096" y="4176977"/>
                            <a:ext cx="455905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800" i="1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Age</a:t>
                            </a:r>
                            <a:r>
                              <a:rPr lang="en-GB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68" name="Straight Connector 67"/>
                          <p:cNvCxnSpPr/>
                          <p:nvPr/>
                        </p:nvCxnSpPr>
                        <p:spPr>
                          <a:xfrm flipV="1">
                            <a:off x="3801324" y="4340437"/>
                            <a:ext cx="0" cy="124424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69" name="TextBox 68"/>
                          <p:cNvSpPr txBox="1"/>
                          <p:nvPr/>
                        </p:nvSpPr>
                        <p:spPr>
                          <a:xfrm>
                            <a:off x="2434977" y="4268126"/>
                            <a:ext cx="455905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10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RB</a:t>
                            </a:r>
                            <a:endPara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70" name="TextBox 69"/>
                          <p:cNvSpPr txBox="1"/>
                          <p:nvPr/>
                        </p:nvSpPr>
                        <p:spPr>
                          <a:xfrm>
                            <a:off x="7777618" y="4268126"/>
                            <a:ext cx="455905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10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LB</a:t>
                            </a:r>
                            <a:endParaRPr lang="en-US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71" name="TextBox 70"/>
                          <p:cNvSpPr txBox="1"/>
                          <p:nvPr/>
                        </p:nvSpPr>
                        <p:spPr>
                          <a:xfrm>
                            <a:off x="7044632" y="4424893"/>
                            <a:ext cx="563118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800" dirty="0" err="1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nptI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72" name="TextBox 71"/>
                          <p:cNvSpPr txBox="1"/>
                          <p:nvPr/>
                        </p:nvSpPr>
                        <p:spPr>
                          <a:xfrm>
                            <a:off x="6139140" y="4427702"/>
                            <a:ext cx="403129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8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p19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73" name="Straight Connector 72"/>
                          <p:cNvCxnSpPr/>
                          <p:nvPr/>
                        </p:nvCxnSpPr>
                        <p:spPr>
                          <a:xfrm flipV="1">
                            <a:off x="5099081" y="4337848"/>
                            <a:ext cx="0" cy="124424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74" name="TextBox 73"/>
                          <p:cNvSpPr txBox="1"/>
                          <p:nvPr/>
                        </p:nvSpPr>
                        <p:spPr>
                          <a:xfrm>
                            <a:off x="4847784" y="4176977"/>
                            <a:ext cx="502593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800" i="1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Xho</a:t>
                            </a:r>
                            <a:r>
                              <a:rPr lang="en-GB" sz="8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I</a:t>
                            </a:r>
                            <a:endPara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75" name="Straight Connector 74"/>
                          <p:cNvCxnSpPr/>
                          <p:nvPr/>
                        </p:nvCxnSpPr>
                        <p:spPr>
                          <a:xfrm>
                            <a:off x="3182112" y="4438962"/>
                            <a:ext cx="590936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rgbClr val="FFFF00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76" name="Straight Connector 75"/>
                          <p:cNvCxnSpPr/>
                          <p:nvPr/>
                        </p:nvCxnSpPr>
                        <p:spPr>
                          <a:xfrm>
                            <a:off x="5152807" y="4438962"/>
                            <a:ext cx="372184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rgbClr val="FFFF00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50" name="TextBox 49"/>
                        <p:cNvSpPr txBox="1"/>
                        <p:nvPr/>
                      </p:nvSpPr>
                      <p:spPr>
                        <a:xfrm>
                          <a:off x="3178494" y="4293436"/>
                          <a:ext cx="58080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6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PMV 5’UTR</a:t>
                          </a:r>
                          <a:endParaRPr lang="en-US" sz="6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51" name="TextBox 50"/>
                        <p:cNvSpPr txBox="1"/>
                        <p:nvPr/>
                      </p:nvSpPr>
                      <p:spPr>
                        <a:xfrm>
                          <a:off x="5042373" y="4283694"/>
                          <a:ext cx="58080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6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PMV 3’UTR</a:t>
                          </a:r>
                          <a:endParaRPr lang="en-US" sz="6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48" name="TextBox 47"/>
                      <p:cNvSpPr txBox="1"/>
                      <p:nvPr/>
                    </p:nvSpPr>
                    <p:spPr>
                      <a:xfrm>
                        <a:off x="3169412" y="3602194"/>
                        <a:ext cx="1707458" cy="41549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100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EAQ-</a:t>
                        </a:r>
                        <a:r>
                          <a:rPr lang="en-GB" sz="1100" i="1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T</a:t>
                        </a:r>
                        <a:r>
                          <a:rPr lang="en-GB" sz="1100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Zera</a:t>
                        </a:r>
                        <a:r>
                          <a:rPr lang="en-GB" sz="1100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® </a:t>
                        </a:r>
                        <a:r>
                          <a:rPr lang="en-GB" sz="11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  <a:r>
                          <a:rPr lang="en-GB" sz="11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VP2</a:t>
                        </a:r>
                        <a:endPara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  <a:p>
                        <a:pPr algn="ctr"/>
                        <a:r>
                          <a:rPr lang="en-GB" sz="10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</a:t>
                        </a:r>
                        <a:endPara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46" name="Rounded Rectangle 45"/>
                    <p:cNvSpPr/>
                    <p:nvPr/>
                  </p:nvSpPr>
                  <p:spPr>
                    <a:xfrm>
                      <a:off x="2435090" y="4120896"/>
                      <a:ext cx="1310680" cy="169548"/>
                    </a:xfrm>
                    <a:prstGeom prst="round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5" name="Group 14"/>
                  <p:cNvGrpSpPr/>
                  <p:nvPr/>
                </p:nvGrpSpPr>
                <p:grpSpPr>
                  <a:xfrm>
                    <a:off x="1041743" y="1674425"/>
                    <a:ext cx="5798546" cy="1100302"/>
                    <a:chOff x="1072521" y="311803"/>
                    <a:chExt cx="5798546" cy="1100302"/>
                  </a:xfrm>
                </p:grpSpPr>
                <p:grpSp>
                  <p:nvGrpSpPr>
                    <p:cNvPr id="16" name="Group 15"/>
                    <p:cNvGrpSpPr/>
                    <p:nvPr/>
                  </p:nvGrpSpPr>
                  <p:grpSpPr>
                    <a:xfrm>
                      <a:off x="1072521" y="757121"/>
                      <a:ext cx="5798546" cy="654984"/>
                      <a:chOff x="2434977" y="4176977"/>
                      <a:chExt cx="5798546" cy="654984"/>
                    </a:xfrm>
                  </p:grpSpPr>
                  <p:grpSp>
                    <p:nvGrpSpPr>
                      <p:cNvPr id="18" name="Group 17"/>
                      <p:cNvGrpSpPr/>
                      <p:nvPr/>
                    </p:nvGrpSpPr>
                    <p:grpSpPr>
                      <a:xfrm>
                        <a:off x="2434977" y="4176977"/>
                        <a:ext cx="5798546" cy="654984"/>
                        <a:chOff x="2434977" y="4176977"/>
                        <a:chExt cx="5798546" cy="654984"/>
                      </a:xfrm>
                    </p:grpSpPr>
                    <p:cxnSp>
                      <p:nvCxnSpPr>
                        <p:cNvPr id="21" name="Straight Connector 20"/>
                        <p:cNvCxnSpPr>
                          <a:endCxn id="23" idx="3"/>
                        </p:cNvCxnSpPr>
                        <p:nvPr/>
                      </p:nvCxnSpPr>
                      <p:spPr>
                        <a:xfrm>
                          <a:off x="2670048" y="4535424"/>
                          <a:ext cx="5358383" cy="4572"/>
                        </a:xfrm>
                        <a:prstGeom prst="line">
                          <a:avLst/>
                        </a:prstGeom>
                        <a:ln w="254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2" name="Rectangle 21"/>
                        <p:cNvSpPr/>
                        <p:nvPr/>
                      </p:nvSpPr>
                      <p:spPr>
                        <a:xfrm>
                          <a:off x="2651760" y="4462272"/>
                          <a:ext cx="45719" cy="155448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3" name="Rectangle 22"/>
                        <p:cNvSpPr/>
                        <p:nvPr/>
                      </p:nvSpPr>
                      <p:spPr>
                        <a:xfrm>
                          <a:off x="7982712" y="4462272"/>
                          <a:ext cx="45719" cy="155448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4" name="Right Arrow 23"/>
                        <p:cNvSpPr/>
                        <p:nvPr/>
                      </p:nvSpPr>
                      <p:spPr>
                        <a:xfrm>
                          <a:off x="2909170" y="4427702"/>
                          <a:ext cx="350520" cy="227397"/>
                        </a:xfrm>
                        <a:prstGeom prst="rightArrow">
                          <a:avLst/>
                        </a:prstGeom>
                        <a:solidFill>
                          <a:srgbClr val="00B0F0"/>
                        </a:solidFill>
                        <a:ln>
                          <a:solidFill>
                            <a:srgbClr val="00B0F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5" name="Right Arrow 24"/>
                        <p:cNvSpPr/>
                        <p:nvPr/>
                      </p:nvSpPr>
                      <p:spPr>
                        <a:xfrm>
                          <a:off x="5466442" y="4427702"/>
                          <a:ext cx="350520" cy="227397"/>
                        </a:xfrm>
                        <a:prstGeom prst="rightArrow">
                          <a:avLst/>
                        </a:prstGeom>
                        <a:solidFill>
                          <a:srgbClr val="00B0F0"/>
                        </a:solidFill>
                        <a:ln>
                          <a:solidFill>
                            <a:srgbClr val="00B0F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6" name="Right Arrow 25"/>
                        <p:cNvSpPr/>
                        <p:nvPr/>
                      </p:nvSpPr>
                      <p:spPr>
                        <a:xfrm>
                          <a:off x="5195170" y="4427702"/>
                          <a:ext cx="222504" cy="227397"/>
                        </a:xfrm>
                        <a:prstGeom prst="rightArrow">
                          <a:avLst/>
                        </a:prstGeom>
                        <a:solidFill>
                          <a:srgbClr val="FF0000"/>
                        </a:solidFill>
                        <a:ln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7" name="Right Arrow 26"/>
                        <p:cNvSpPr/>
                        <p:nvPr/>
                      </p:nvSpPr>
                      <p:spPr>
                        <a:xfrm>
                          <a:off x="5893162" y="4427702"/>
                          <a:ext cx="390144" cy="227397"/>
                        </a:xfrm>
                        <a:prstGeom prst="rightArrow">
                          <a:avLst/>
                        </a:prstGeom>
                        <a:solidFill>
                          <a:srgbClr val="CC00CC"/>
                        </a:solidFill>
                        <a:ln>
                          <a:solidFill>
                            <a:srgbClr val="CC00CC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8" name="Right Arrow 27"/>
                        <p:cNvSpPr/>
                        <p:nvPr/>
                      </p:nvSpPr>
                      <p:spPr>
                        <a:xfrm>
                          <a:off x="6332074" y="4427702"/>
                          <a:ext cx="541020" cy="227397"/>
                        </a:xfrm>
                        <a:prstGeom prst="rightArrow">
                          <a:avLst/>
                        </a:prstGeom>
                        <a:solidFill>
                          <a:srgbClr val="FF0000"/>
                        </a:solidFill>
                        <a:ln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9" name="Right Arrow 28"/>
                        <p:cNvSpPr/>
                        <p:nvPr/>
                      </p:nvSpPr>
                      <p:spPr>
                        <a:xfrm>
                          <a:off x="7146652" y="4427702"/>
                          <a:ext cx="563118" cy="227397"/>
                        </a:xfrm>
                        <a:prstGeom prst="rightArrow">
                          <a:avLst/>
                        </a:prstGeom>
                        <a:solidFill>
                          <a:srgbClr val="0070C0"/>
                        </a:solidFill>
                        <a:ln>
                          <a:solidFill>
                            <a:srgbClr val="0070C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0" name="Rounded Rectangle 29"/>
                        <p:cNvSpPr/>
                        <p:nvPr/>
                      </p:nvSpPr>
                      <p:spPr>
                        <a:xfrm>
                          <a:off x="4518645" y="4467627"/>
                          <a:ext cx="204053" cy="173590"/>
                        </a:xfrm>
                        <a:prstGeom prst="roundRect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bg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" name="TextBox 30"/>
                        <p:cNvSpPr txBox="1"/>
                        <p:nvPr/>
                      </p:nvSpPr>
                      <p:spPr>
                        <a:xfrm>
                          <a:off x="4249221" y="4176977"/>
                          <a:ext cx="455905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800" i="1" dirty="0" err="1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lu</a:t>
                          </a:r>
                          <a:r>
                            <a:rPr lang="en-GB" sz="800" dirty="0" err="1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</a:t>
                          </a:r>
                          <a:endPara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2" name="Rounded Rectangle 31"/>
                        <p:cNvSpPr/>
                        <p:nvPr/>
                      </p:nvSpPr>
                      <p:spPr>
                        <a:xfrm>
                          <a:off x="4440637" y="4467627"/>
                          <a:ext cx="78376" cy="148890"/>
                        </a:xfrm>
                        <a:prstGeom prst="roundRect">
                          <a:avLst/>
                        </a:prstGeom>
                        <a:solidFill>
                          <a:srgbClr val="00B0F0"/>
                        </a:solidFill>
                        <a:ln>
                          <a:solidFill>
                            <a:srgbClr val="00B0F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3" name="Rounded Rectangle 32"/>
                        <p:cNvSpPr/>
                        <p:nvPr/>
                      </p:nvSpPr>
                      <p:spPr>
                        <a:xfrm>
                          <a:off x="3955929" y="4467627"/>
                          <a:ext cx="486988" cy="148890"/>
                        </a:xfrm>
                        <a:prstGeom prst="roundRect">
                          <a:avLst/>
                        </a:prstGeom>
                        <a:solidFill>
                          <a:srgbClr val="FF99FF"/>
                        </a:solidFill>
                        <a:ln>
                          <a:solidFill>
                            <a:srgbClr val="FF99FF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cxnSp>
                      <p:nvCxnSpPr>
                        <p:cNvPr id="34" name="Straight Connector 33"/>
                        <p:cNvCxnSpPr/>
                        <p:nvPr/>
                      </p:nvCxnSpPr>
                      <p:spPr>
                        <a:xfrm flipV="1">
                          <a:off x="4517604" y="4340437"/>
                          <a:ext cx="0" cy="124424"/>
                        </a:xfrm>
                        <a:prstGeom prst="line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5" name="TextBox 34"/>
                        <p:cNvSpPr txBox="1"/>
                        <p:nvPr/>
                      </p:nvSpPr>
                      <p:spPr>
                        <a:xfrm>
                          <a:off x="3727976" y="4176977"/>
                          <a:ext cx="455905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800" i="1" dirty="0" err="1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ge</a:t>
                          </a:r>
                          <a:r>
                            <a:rPr lang="en-GB" sz="800" dirty="0" err="1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</a:t>
                          </a:r>
                          <a:endPara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cxnSp>
                      <p:nvCxnSpPr>
                        <p:cNvPr id="36" name="Straight Connector 35"/>
                        <p:cNvCxnSpPr/>
                        <p:nvPr/>
                      </p:nvCxnSpPr>
                      <p:spPr>
                        <a:xfrm flipV="1">
                          <a:off x="3956772" y="4340437"/>
                          <a:ext cx="0" cy="124424"/>
                        </a:xfrm>
                        <a:prstGeom prst="line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7" name="TextBox 36"/>
                        <p:cNvSpPr txBox="1"/>
                        <p:nvPr/>
                      </p:nvSpPr>
                      <p:spPr>
                        <a:xfrm>
                          <a:off x="2434977" y="4268126"/>
                          <a:ext cx="45590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RB</a:t>
                          </a:r>
                          <a:endPara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8" name="TextBox 37"/>
                        <p:cNvSpPr txBox="1"/>
                        <p:nvPr/>
                      </p:nvSpPr>
                      <p:spPr>
                        <a:xfrm>
                          <a:off x="7777618" y="4268126"/>
                          <a:ext cx="45590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0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LB</a:t>
                          </a:r>
                          <a:endPara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9" name="TextBox 38"/>
                        <p:cNvSpPr txBox="1"/>
                        <p:nvPr/>
                      </p:nvSpPr>
                      <p:spPr>
                        <a:xfrm>
                          <a:off x="7055212" y="4427702"/>
                          <a:ext cx="563118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 err="1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ptII</a:t>
                          </a:r>
                          <a:endPara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0" name="TextBox 39"/>
                        <p:cNvSpPr txBox="1"/>
                        <p:nvPr/>
                      </p:nvSpPr>
                      <p:spPr>
                        <a:xfrm>
                          <a:off x="5855676" y="4427702"/>
                          <a:ext cx="403129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p19</a:t>
                          </a:r>
                          <a:endPara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cxnSp>
                      <p:nvCxnSpPr>
                        <p:cNvPr id="41" name="Straight Connector 40"/>
                        <p:cNvCxnSpPr/>
                        <p:nvPr/>
                      </p:nvCxnSpPr>
                      <p:spPr>
                        <a:xfrm flipV="1">
                          <a:off x="4724981" y="4535424"/>
                          <a:ext cx="0" cy="124424"/>
                        </a:xfrm>
                        <a:prstGeom prst="line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2" name="TextBox 41"/>
                        <p:cNvSpPr txBox="1"/>
                        <p:nvPr/>
                      </p:nvSpPr>
                      <p:spPr>
                        <a:xfrm>
                          <a:off x="4494372" y="4616517"/>
                          <a:ext cx="502593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800" i="1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Xho</a:t>
                          </a:r>
                          <a:r>
                            <a:rPr lang="en-GB" sz="80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</a:t>
                          </a:r>
                          <a:endParaRPr lang="en-US" sz="8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cxnSp>
                      <p:nvCxnSpPr>
                        <p:cNvPr id="43" name="Straight Connector 42"/>
                        <p:cNvCxnSpPr/>
                        <p:nvPr/>
                      </p:nvCxnSpPr>
                      <p:spPr>
                        <a:xfrm>
                          <a:off x="3364992" y="4438962"/>
                          <a:ext cx="590936" cy="0"/>
                        </a:xfrm>
                        <a:prstGeom prst="line">
                          <a:avLst/>
                        </a:prstGeom>
                        <a:ln w="19050">
                          <a:solidFill>
                            <a:srgbClr val="FFFF00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4" name="Straight Connector 43"/>
                        <p:cNvCxnSpPr/>
                        <p:nvPr/>
                      </p:nvCxnSpPr>
                      <p:spPr>
                        <a:xfrm>
                          <a:off x="4741327" y="4438962"/>
                          <a:ext cx="372184" cy="0"/>
                        </a:xfrm>
                        <a:prstGeom prst="line">
                          <a:avLst/>
                        </a:prstGeom>
                        <a:ln w="19050">
                          <a:solidFill>
                            <a:srgbClr val="FFFF00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19" name="TextBox 18"/>
                      <p:cNvSpPr txBox="1"/>
                      <p:nvPr/>
                    </p:nvSpPr>
                    <p:spPr>
                      <a:xfrm>
                        <a:off x="3361374" y="4293436"/>
                        <a:ext cx="58080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6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PMV 5’UTR</a:t>
                        </a:r>
                        <a:endPara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0" name="TextBox 19"/>
                      <p:cNvSpPr txBox="1"/>
                      <p:nvPr/>
                    </p:nvSpPr>
                    <p:spPr>
                      <a:xfrm>
                        <a:off x="4657729" y="4293436"/>
                        <a:ext cx="58080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6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PMV 3’UTR</a:t>
                        </a:r>
                        <a:endPara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7" name="TextBox 16"/>
                    <p:cNvSpPr txBox="1"/>
                    <p:nvPr/>
                  </p:nvSpPr>
                  <p:spPr>
                    <a:xfrm>
                      <a:off x="3178148" y="311803"/>
                      <a:ext cx="1405361" cy="83099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Q-</a:t>
                      </a:r>
                      <a:r>
                        <a:rPr lang="en-GB" sz="11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</a:t>
                      </a:r>
                      <a:r>
                        <a:rPr lang="en-GB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ra</a:t>
                      </a:r>
                      <a:r>
                        <a:rPr lang="en-GB" sz="11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® </a:t>
                      </a:r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GB" sz="1100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u</a:t>
                      </a:r>
                      <a:r>
                        <a:rPr lang="en-GB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/ </a:t>
                      </a:r>
                      <a:r>
                        <a:rPr lang="en-GB" sz="11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ho</a:t>
                      </a:r>
                      <a:r>
                        <a:rPr lang="en-GB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)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10" name="TextBox 9"/>
                <p:cNvSpPr txBox="1"/>
                <p:nvPr/>
              </p:nvSpPr>
              <p:spPr>
                <a:xfrm>
                  <a:off x="761761" y="498290"/>
                  <a:ext cx="36602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dirty="0" smtClean="0">
                      <a:latin typeface="Arial" panose="020B0604020202020204" pitchFamily="34" charset="0"/>
                      <a:cs typeface="Arial" pitchFamily="34" charset="0"/>
                    </a:rPr>
                    <a:t>(a)</a:t>
                  </a:r>
                  <a:endParaRPr lang="en-GB" sz="11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761761" y="1833480"/>
                  <a:ext cx="44483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dirty="0" smtClean="0">
                      <a:latin typeface="Arial" panose="020B0604020202020204" pitchFamily="34" charset="0"/>
                      <a:cs typeface="Arial" pitchFamily="34" charset="0"/>
                    </a:rPr>
                    <a:t>(b)</a:t>
                  </a:r>
                  <a:endParaRPr lang="en-GB" sz="11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761761" y="3285386"/>
                  <a:ext cx="48047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dirty="0" smtClean="0">
                      <a:latin typeface="Arial" panose="020B0604020202020204" pitchFamily="34" charset="0"/>
                      <a:cs typeface="Arial" pitchFamily="34" charset="0"/>
                    </a:rPr>
                    <a:t>(c)</a:t>
                  </a:r>
                  <a:endParaRPr lang="en-GB" sz="11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2576444" y="2377006"/>
                <a:ext cx="47276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era</a:t>
                </a:r>
                <a:r>
                  <a:rPr lang="en-GB" sz="8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® 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25637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1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</cp:revision>
  <dcterms:created xsi:type="dcterms:W3CDTF">2017-04-13T13:54:15Z</dcterms:created>
  <dcterms:modified xsi:type="dcterms:W3CDTF">2017-04-13T13:54:51Z</dcterms:modified>
</cp:coreProperties>
</file>